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F4F279-37BB-4001-804A-6758FB3E47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45B51B-66D7-4D1A-B32C-460BDAA92F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98EEDC-B86D-40AC-88B4-15231141051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C7CDE0-3731-4A0B-B13D-F171EFF1DC5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1A2F9C-D40B-471D-8C0D-17CDF2D79C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0BDC0D-E925-4E31-95BC-0221972628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6E6A2A-924C-48A6-8EC3-CFC7E3343D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E42BD4-D264-41F1-A1C8-5614021FBB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65F623-97FA-43B6-9AF0-159EDBD269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30DFBE-A67C-41C2-9EB3-CE188B9F6D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E946A3-250D-42B6-B7D0-FAF070CDD7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5AA96A-54D8-4F2A-B63F-4233FCBFDB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1B39A6-B51E-4398-BED4-B5763908B2D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ct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752480" y="1371600"/>
          <a:ext cx="5905800" cy="26542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52480" y="1371600"/>
                    <a:ext cx="5905800" cy="2654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6160680" y="6553080"/>
            <a:ext cx="1858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ileti et al. Figure 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447920" y="4419720"/>
            <a:ext cx="693396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2. Lactobacilli do not differ in their ability to drive CD4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D25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oxp3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T regulatory cell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Cs were incubated or not with the reported live bacterial strains for 1 h in medium without antibiotics, washed and incubated for 23 h in medium with antibiotics. Cells were washed and incubated with naïve CD4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D45RA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ells for 5 days (Ratio 1:10 DC:T cells). Cells were collected and analyzed by cytofluorimetry for the expression of CD4, CD25 and intracellular Foxp3. S. typhim., Salmonella typhimurium; L. plant., L. plantarum; L. parac., L. paracasei B21060; LGG, L. rhamnosus GG. One representative of three independent experiments is show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7T11:41:03Z</dcterms:created>
  <dc:creator>Comp.Dept. IFOM</dc:creator>
  <dc:description/>
  <dc:language>en-US</dc:language>
  <cp:lastModifiedBy>Comp.Dept. IFOM</cp:lastModifiedBy>
  <dcterms:modified xsi:type="dcterms:W3CDTF">2009-08-17T16:04:37Z</dcterms:modified>
  <cp:revision>2</cp:revision>
  <dc:subject/>
  <dc:title>PowerPoint Presentation</dc:title>
</cp:coreProperties>
</file>